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F6214-A8BC-4BB9-80A2-412F96D524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C8C77-6F84-43B2-A840-C8C11B01AE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8B81F-D01D-4E58-AAD3-E9ABB137D7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F0692-F20C-41E5-A339-4A4B5EA5FC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FD101-9A75-48C5-8BB0-E434952B67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B4B2E-9B2F-4681-80B8-10575B6C6C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A07F5-4C77-455A-A0B0-2D59A5E6F9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550C80-50F2-41ED-8CEA-5BD3922566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6D15B-A9ED-432E-AAE0-9318DFD561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205B9-AF76-4F3A-8BE5-5E090B3EE9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6B12C-FDEA-4A20-B351-DA12F45AB7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1E9569-E04F-496A-BAB4-9DABD47BBF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6C2BEB-C433-4851-B5BF-B6DC07B769F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71680" y="357120"/>
          <a:ext cx="5594040" cy="3567240"/>
        </p:xfrm>
        <a:graphic>
          <a:graphicData uri="http://schemas.openxmlformats.org/drawingml/2006/table">
            <a:tbl>
              <a:tblPr/>
              <a:tblGrid>
                <a:gridCol w="1128600"/>
                <a:gridCol w="3530520"/>
                <a:gridCol w="934920"/>
              </a:tblGrid>
              <a:tr h="131400">
                <a:tc gridSpan="3"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ble S1. Strains used in 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140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rai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otype and featur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ference or sourc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. pneumophil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33200"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rogroup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96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R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mogeneous salt sensitive isolate of wild type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. pneumorhila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AM5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dosky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. (a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N1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R32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63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N1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R32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N1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R32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284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N1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R32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275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N1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R32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678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N1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R32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1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N101 + pTH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1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N102 + pTH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hiladelphia 1,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sdR rpsL thy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erger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</a:t>
                      </a:r>
                      <a:r>
                        <a:rPr b="0" i="1" lang="ja-JP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b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18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linical isolate from the Wadsworth Veterans Administration Hospital, Los Angel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bu Kwaik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c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32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ELA31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R32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otA3118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Tn903dll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ac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Z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dosky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. (a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18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rogroup 5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ＭＳ Ｐ明朝"/>
                        </a:rPr>
                        <a:t>　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C2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e GTC strains were obtained from the Gifu Type Culture Collection at Gifu University Graduate School of Medicine, Japan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yake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d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rogroup 6  GTC7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e GTC strai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yake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d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rogroup 7  GTC7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e GTC strai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yake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d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. bozemanii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C2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e GTC strai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yake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d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14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. micdadei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GTC2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e GTC strai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yake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d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616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. dumoffii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ＭＳ Ｐ明朝"/>
                        </a:rPr>
                        <a:t>　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C3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e GTC strai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yake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d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32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. brunensis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C5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e GTC strai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yake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d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. gratiana 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C6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e GTC strai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yake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d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テキスト ボックス 2"/>
          <p:cNvSpPr/>
          <p:nvPr/>
        </p:nvSpPr>
        <p:spPr>
          <a:xfrm>
            <a:off x="404640" y="3995640"/>
            <a:ext cx="645336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 Sadosky AB, Wiater LA, Shuman HA (1993) Identification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gionella pneumophil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s required for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owth within and killing of human macrophages. Infect Immun 61: 5361-5373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Berger KH, Isberg RR (1993) Two distinct defects in intracellular growth complemented by a single genetic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us i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gionella pneumophil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Mol Microbiol 7: 7-19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. Abu Kwaik Y, Engleberg NC (1994) Cloning and molecular characterization of a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Legionella pneumophil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ene induced by intracellular infection and by various in vitro stress conditions. Mol Microbiol 13: 243-251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d. Miyake M, Watanabe T, Koike H, Molmeret M, Imai Y, et al. (2005) Characterization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Legionella pneumophila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mi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, a gene essential for infectivity of protozoa and macrophages. Infect Immun 73: 6272-6282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04T12:57:45Z</dcterms:created>
  <dc:creator> 平田源内</dc:creator>
  <dc:description/>
  <dc:language>en-US</dc:language>
  <cp:lastModifiedBy>MiyakeMasaki</cp:lastModifiedBy>
  <dcterms:modified xsi:type="dcterms:W3CDTF">2010-06-30T05:33:00Z</dcterms:modified>
  <cp:revision>121</cp:revision>
  <dc:subject/>
  <dc:title>スライド 1</dc:title>
</cp:coreProperties>
</file>